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3"/>
  </p:notesMasterIdLst>
  <p:sldIdLst>
    <p:sldId id="26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867" autoAdjust="0"/>
    <p:restoredTop sz="93742" autoAdjust="0"/>
  </p:normalViewPr>
  <p:slideViewPr>
    <p:cSldViewPr snapToGrid="0" snapToObjects="1">
      <p:cViewPr varScale="1">
        <p:scale>
          <a:sx n="99" d="100"/>
          <a:sy n="99" d="100"/>
        </p:scale>
        <p:origin x="2094" y="78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B3374A-F7C5-4205-BDC3-C7A08D18564E}" type="datetimeFigureOut">
              <a:rPr lang="zh-CN" altLang="en-US" smtClean="0"/>
              <a:t>2025/1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8E24C60-C450-430D-9A33-9BF17A708B7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4A499-FA57-2A45-AB09-5EB1FD35A366}" type="datetimeFigureOut">
              <a:rPr kumimoji="1" lang="zh-CN" altLang="en-US" smtClean="0"/>
              <a:t>2025/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E7A9-3147-EA47-9E2A-88CA67DD73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4A499-FA57-2A45-AB09-5EB1FD35A366}" type="datetimeFigureOut">
              <a:rPr kumimoji="1" lang="zh-CN" altLang="en-US" smtClean="0"/>
              <a:t>2025/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E7A9-3147-EA47-9E2A-88CA67DD73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4A499-FA57-2A45-AB09-5EB1FD35A366}" type="datetimeFigureOut">
              <a:rPr kumimoji="1" lang="zh-CN" altLang="en-US" smtClean="0"/>
              <a:t>2025/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E7A9-3147-EA47-9E2A-88CA67DD73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4A499-FA57-2A45-AB09-5EB1FD35A366}" type="datetimeFigureOut">
              <a:rPr kumimoji="1" lang="zh-CN" altLang="en-US" smtClean="0"/>
              <a:t>2025/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E7A9-3147-EA47-9E2A-88CA67DD73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4A499-FA57-2A45-AB09-5EB1FD35A366}" type="datetimeFigureOut">
              <a:rPr kumimoji="1" lang="zh-CN" altLang="en-US" smtClean="0"/>
              <a:t>2025/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E7A9-3147-EA47-9E2A-88CA67DD73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4A499-FA57-2A45-AB09-5EB1FD35A366}" type="datetimeFigureOut">
              <a:rPr kumimoji="1" lang="zh-CN" altLang="en-US" smtClean="0"/>
              <a:t>2025/1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E7A9-3147-EA47-9E2A-88CA67DD73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4A499-FA57-2A45-AB09-5EB1FD35A366}" type="datetimeFigureOut">
              <a:rPr kumimoji="1" lang="zh-CN" altLang="en-US" smtClean="0"/>
              <a:t>2025/1/16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E7A9-3147-EA47-9E2A-88CA67DD73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4A499-FA57-2A45-AB09-5EB1FD35A366}" type="datetimeFigureOut">
              <a:rPr kumimoji="1" lang="zh-CN" altLang="en-US" smtClean="0"/>
              <a:t>2025/1/16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E7A9-3147-EA47-9E2A-88CA67DD73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4A499-FA57-2A45-AB09-5EB1FD35A366}" type="datetimeFigureOut">
              <a:rPr kumimoji="1" lang="zh-CN" altLang="en-US" smtClean="0"/>
              <a:t>2025/1/16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E7A9-3147-EA47-9E2A-88CA67DD73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4A499-FA57-2A45-AB09-5EB1FD35A366}" type="datetimeFigureOut">
              <a:rPr kumimoji="1" lang="zh-CN" altLang="en-US" smtClean="0"/>
              <a:t>2025/1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E7A9-3147-EA47-9E2A-88CA67DD73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4A499-FA57-2A45-AB09-5EB1FD35A366}" type="datetimeFigureOut">
              <a:rPr kumimoji="1" lang="zh-CN" altLang="en-US" smtClean="0"/>
              <a:t>2025/1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E7A9-3147-EA47-9E2A-88CA67DD73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D4A499-FA57-2A45-AB09-5EB1FD35A366}" type="datetimeFigureOut">
              <a:rPr kumimoji="1" lang="zh-CN" altLang="en-US" smtClean="0"/>
              <a:t>2025/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48E7A9-3147-EA47-9E2A-88CA67DD736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组合 22"/>
          <p:cNvGrpSpPr/>
          <p:nvPr/>
        </p:nvGrpSpPr>
        <p:grpSpPr>
          <a:xfrm>
            <a:off x="3198915" y="2076463"/>
            <a:ext cx="2418230" cy="683009"/>
            <a:chOff x="9670572" y="2084968"/>
            <a:chExt cx="2418230" cy="683009"/>
          </a:xfrm>
        </p:grpSpPr>
        <p:pic>
          <p:nvPicPr>
            <p:cNvPr id="14" name="图片 13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963" t="50304" r="45634" b="45280"/>
            <a:stretch>
              <a:fillRect/>
            </a:stretch>
          </p:blipFill>
          <p:spPr>
            <a:xfrm>
              <a:off x="10159021" y="2510548"/>
              <a:ext cx="1190975" cy="257429"/>
            </a:xfrm>
            <a:prstGeom prst="rect">
              <a:avLst/>
            </a:prstGeom>
          </p:spPr>
        </p:pic>
        <p:pic>
          <p:nvPicPr>
            <p:cNvPr id="15" name="图片 1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832" t="52612" r="45805" b="43597"/>
            <a:stretch>
              <a:fillRect/>
            </a:stretch>
          </p:blipFill>
          <p:spPr>
            <a:xfrm>
              <a:off x="10163912" y="2278090"/>
              <a:ext cx="1192011" cy="221546"/>
            </a:xfrm>
            <a:prstGeom prst="rect">
              <a:avLst/>
            </a:prstGeom>
          </p:spPr>
        </p:pic>
        <p:sp>
          <p:nvSpPr>
            <p:cNvPr id="16" name="文本框 15"/>
            <p:cNvSpPr txBox="1"/>
            <p:nvPr/>
          </p:nvSpPr>
          <p:spPr>
            <a:xfrm>
              <a:off x="10095341" y="2084968"/>
              <a:ext cx="13193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12h     24h     36h     48h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9716758" y="2289640"/>
              <a:ext cx="4943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P6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9670572" y="2490278"/>
              <a:ext cx="5580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actin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11301929" y="2384931"/>
              <a:ext cx="7868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HBZ2303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24" name="图片 2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849" t="53090" r="46926" b="43563"/>
          <a:stretch>
            <a:fillRect/>
          </a:stretch>
        </p:blipFill>
        <p:spPr>
          <a:xfrm flipH="1">
            <a:off x="3687364" y="3409773"/>
            <a:ext cx="1190974" cy="196726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239" t="52786" r="41560" b="44174"/>
          <a:stretch>
            <a:fillRect/>
          </a:stretch>
        </p:blipFill>
        <p:spPr>
          <a:xfrm flipH="1">
            <a:off x="3687364" y="3186464"/>
            <a:ext cx="1190974" cy="196725"/>
          </a:xfrm>
          <a:prstGeom prst="rect">
            <a:avLst/>
          </a:prstGeom>
        </p:spPr>
      </p:pic>
      <p:sp>
        <p:nvSpPr>
          <p:cNvPr id="28" name="文本框 27"/>
          <p:cNvSpPr txBox="1"/>
          <p:nvPr/>
        </p:nvSpPr>
        <p:spPr>
          <a:xfrm>
            <a:off x="3623168" y="2992438"/>
            <a:ext cx="13193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12h     24h     36h     48h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3245102" y="3161341"/>
            <a:ext cx="4943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P6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3198915" y="3348331"/>
            <a:ext cx="5580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4830273" y="3216103"/>
            <a:ext cx="7868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HBZ2304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1263580" y="888646"/>
            <a:ext cx="8673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911860" y="4279900"/>
            <a:ext cx="667194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Fig. S1. The expression of viral VP6 protein was analyzed at different infection periods (12, 24, 36 and 48 HPI) in MA104 cells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91</TotalTime>
  <Words>48</Words>
  <Application>Microsoft Office PowerPoint</Application>
  <PresentationFormat>全屏显示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User</dc:creator>
  <cp:lastModifiedBy>hp</cp:lastModifiedBy>
  <cp:revision>61</cp:revision>
  <dcterms:created xsi:type="dcterms:W3CDTF">2024-04-21T02:33:00Z</dcterms:created>
  <dcterms:modified xsi:type="dcterms:W3CDTF">2025-01-16T04:42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6F18B6D0EFE49AC80E456BD4260C519_12</vt:lpwstr>
  </property>
  <property fmtid="{D5CDD505-2E9C-101B-9397-08002B2CF9AE}" pid="3" name="KSOProductBuildVer">
    <vt:lpwstr>2052-12.1.0.18912</vt:lpwstr>
  </property>
</Properties>
</file>